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3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36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 up of a map&#10;&#10;Description automatically generated">
            <a:extLst>
              <a:ext uri="{FF2B5EF4-FFF2-40B4-BE49-F238E27FC236}">
                <a16:creationId xmlns:a16="http://schemas.microsoft.com/office/drawing/2014/main" id="{DCDE3525-B302-475D-9CDA-A51A1D132B0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66" t="6320" r="7760" b="9719"/>
          <a:stretch/>
        </p:blipFill>
        <p:spPr>
          <a:xfrm>
            <a:off x="1187985" y="3591714"/>
            <a:ext cx="1919806" cy="158811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B00D495-586A-4E8B-80C1-40CF169F653F}"/>
              </a:ext>
            </a:extLst>
          </p:cNvPr>
          <p:cNvSpPr txBox="1"/>
          <p:nvPr/>
        </p:nvSpPr>
        <p:spPr>
          <a:xfrm>
            <a:off x="102915" y="36492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C5DB43-2DB1-4295-BEF2-B12D3FA9428C}"/>
              </a:ext>
            </a:extLst>
          </p:cNvPr>
          <p:cNvSpPr txBox="1"/>
          <p:nvPr/>
        </p:nvSpPr>
        <p:spPr>
          <a:xfrm>
            <a:off x="3967116" y="5315315"/>
            <a:ext cx="753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TSs (bp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CE0E8A8-5A15-40E8-9157-8A5D6C6BD979}"/>
              </a:ext>
            </a:extLst>
          </p:cNvPr>
          <p:cNvSpPr txBox="1"/>
          <p:nvPr/>
        </p:nvSpPr>
        <p:spPr>
          <a:xfrm>
            <a:off x="4343982" y="2973999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96AB6B1-DEF4-43B1-B07F-146A62692D35}"/>
              </a:ext>
            </a:extLst>
          </p:cNvPr>
          <p:cNvSpPr txBox="1"/>
          <p:nvPr/>
        </p:nvSpPr>
        <p:spPr>
          <a:xfrm>
            <a:off x="3561882" y="297310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8B2BA7-9003-4F20-B115-B95059B47940}"/>
              </a:ext>
            </a:extLst>
          </p:cNvPr>
          <p:cNvSpPr txBox="1"/>
          <p:nvPr/>
        </p:nvSpPr>
        <p:spPr>
          <a:xfrm>
            <a:off x="3965377" y="2973105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a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322D862-5241-4B83-94B4-4836DEC1DFFA}"/>
              </a:ext>
            </a:extLst>
          </p:cNvPr>
          <p:cNvSpPr txBox="1"/>
          <p:nvPr/>
        </p:nvSpPr>
        <p:spPr>
          <a:xfrm>
            <a:off x="4732687" y="2973106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b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ED7EA86-3BA8-4968-AB2F-BECDC01C2B67}"/>
              </a:ext>
            </a:extLst>
          </p:cNvPr>
          <p:cNvSpPr txBox="1"/>
          <p:nvPr/>
        </p:nvSpPr>
        <p:spPr>
          <a:xfrm>
            <a:off x="3273056" y="157271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BCB189D-A18A-4485-9487-13733B952AF8}"/>
              </a:ext>
            </a:extLst>
          </p:cNvPr>
          <p:cNvSpPr txBox="1"/>
          <p:nvPr/>
        </p:nvSpPr>
        <p:spPr>
          <a:xfrm>
            <a:off x="3246120" y="1975605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Kap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A32E8E6-C0B9-4A6F-91D3-2E758E4CD874}"/>
              </a:ext>
            </a:extLst>
          </p:cNvPr>
          <p:cNvSpPr txBox="1"/>
          <p:nvPr/>
        </p:nvSpPr>
        <p:spPr>
          <a:xfrm>
            <a:off x="3237249" y="233576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v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1B9DF48-1DDC-4EF4-ABC3-4FAAC24278BC}"/>
              </a:ext>
            </a:extLst>
          </p:cNvPr>
          <p:cNvSpPr txBox="1"/>
          <p:nvPr/>
        </p:nvSpPr>
        <p:spPr>
          <a:xfrm>
            <a:off x="3227978" y="2717073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b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1959028F-07B8-4872-B86D-3842A0D4E7B8}"/>
              </a:ext>
            </a:extLst>
          </p:cNvPr>
          <p:cNvSpPr txBox="1"/>
          <p:nvPr/>
        </p:nvSpPr>
        <p:spPr>
          <a:xfrm>
            <a:off x="3172968" y="11490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AD617F-6B07-4828-A523-DAA781A31356}"/>
              </a:ext>
            </a:extLst>
          </p:cNvPr>
          <p:cNvSpPr txBox="1"/>
          <p:nvPr/>
        </p:nvSpPr>
        <p:spPr>
          <a:xfrm>
            <a:off x="383958" y="5895485"/>
            <a:ext cx="611315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Comparison of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cleosome occupancy in a few datasets. 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stograms of nucleosome occupancy: Lee et al. [1], Kaplan et al. [2]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vric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 [3],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[4]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root-mean-square-deviation (RMSD) between different dataset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osite plot of the average nucleosome occupancy near transcription start sites (TSSs, left) or transcription termination sites (TTSs, right).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D8AA6F8-00A1-4D49-9C85-5660E5F6F807}"/>
              </a:ext>
            </a:extLst>
          </p:cNvPr>
          <p:cNvSpPr txBox="1"/>
          <p:nvPr/>
        </p:nvSpPr>
        <p:spPr>
          <a:xfrm>
            <a:off x="1642126" y="3180680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ccupancy</a:t>
            </a:r>
          </a:p>
        </p:txBody>
      </p:sp>
      <p:pic>
        <p:nvPicPr>
          <p:cNvPr id="7" name="Picture 6" descr="A picture containing drawing, clock&#10;&#10;Description automatically generated">
            <a:extLst>
              <a:ext uri="{FF2B5EF4-FFF2-40B4-BE49-F238E27FC236}">
                <a16:creationId xmlns:a16="http://schemas.microsoft.com/office/drawing/2014/main" id="{072C344E-15C8-491E-A48F-341A6089069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80" t="6205" r="6311" b="8857"/>
          <a:stretch/>
        </p:blipFill>
        <p:spPr>
          <a:xfrm>
            <a:off x="3576837" y="1537585"/>
            <a:ext cx="1989105" cy="1484985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FA00B0AB-E8C8-4C08-93E8-62887F1613DA}"/>
              </a:ext>
            </a:extLst>
          </p:cNvPr>
          <p:cNvSpPr txBox="1"/>
          <p:nvPr/>
        </p:nvSpPr>
        <p:spPr>
          <a:xfrm>
            <a:off x="1006525" y="5144012"/>
            <a:ext cx="22188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600   -400    -200       0       200    400    60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31EAE98-C24A-40BB-A070-D393F2A1F8A3}"/>
              </a:ext>
            </a:extLst>
          </p:cNvPr>
          <p:cNvSpPr txBox="1"/>
          <p:nvPr/>
        </p:nvSpPr>
        <p:spPr>
          <a:xfrm>
            <a:off x="1805947" y="5312999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SSs (bp)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50DE62E4-3B88-4A24-96C4-4E3CCFB5C5E5}"/>
              </a:ext>
            </a:extLst>
          </p:cNvPr>
          <p:cNvSpPr txBox="1"/>
          <p:nvPr/>
        </p:nvSpPr>
        <p:spPr>
          <a:xfrm>
            <a:off x="937277" y="433425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0C648E7-BCFF-43DA-B099-32B329E0CC56}"/>
              </a:ext>
            </a:extLst>
          </p:cNvPr>
          <p:cNvSpPr txBox="1"/>
          <p:nvPr/>
        </p:nvSpPr>
        <p:spPr>
          <a:xfrm>
            <a:off x="935409" y="406566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DD60C29-8747-49C0-A5C2-3728DA2F8341}"/>
              </a:ext>
            </a:extLst>
          </p:cNvPr>
          <p:cNvSpPr txBox="1"/>
          <p:nvPr/>
        </p:nvSpPr>
        <p:spPr>
          <a:xfrm>
            <a:off x="928813" y="379110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26B07608-3E6E-458C-9A92-406851B48A93}"/>
              </a:ext>
            </a:extLst>
          </p:cNvPr>
          <p:cNvSpPr txBox="1"/>
          <p:nvPr/>
        </p:nvSpPr>
        <p:spPr>
          <a:xfrm>
            <a:off x="935409" y="353291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8D3B180-BACC-4FDC-97A4-74F95FC85F0B}"/>
              </a:ext>
            </a:extLst>
          </p:cNvPr>
          <p:cNvSpPr txBox="1"/>
          <p:nvPr/>
        </p:nvSpPr>
        <p:spPr>
          <a:xfrm rot="16200000">
            <a:off x="470732" y="4238910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ccupancy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ED224B92-9BDE-4FDE-B223-AAF261545EB5}"/>
              </a:ext>
            </a:extLst>
          </p:cNvPr>
          <p:cNvSpPr txBox="1"/>
          <p:nvPr/>
        </p:nvSpPr>
        <p:spPr>
          <a:xfrm>
            <a:off x="654545" y="33880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1AFD4B-D00C-4E30-A36C-241696CEF167}"/>
              </a:ext>
            </a:extLst>
          </p:cNvPr>
          <p:cNvSpPr txBox="1"/>
          <p:nvPr/>
        </p:nvSpPr>
        <p:spPr>
          <a:xfrm>
            <a:off x="928813" y="489034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F135D0-A0FE-4A8F-AD3A-A88DA46B2F1B}"/>
              </a:ext>
            </a:extLst>
          </p:cNvPr>
          <p:cNvSpPr txBox="1"/>
          <p:nvPr/>
        </p:nvSpPr>
        <p:spPr>
          <a:xfrm>
            <a:off x="943873" y="462456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pic>
        <p:nvPicPr>
          <p:cNvPr id="13" name="Picture 12" descr="A close up of a map&#10;&#10;Description automatically generated">
            <a:extLst>
              <a:ext uri="{FF2B5EF4-FFF2-40B4-BE49-F238E27FC236}">
                <a16:creationId xmlns:a16="http://schemas.microsoft.com/office/drawing/2014/main" id="{6E2D8641-070A-4B5E-B548-7567624383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03" t="6320" r="7760" b="8858"/>
          <a:stretch/>
        </p:blipFill>
        <p:spPr>
          <a:xfrm>
            <a:off x="3282696" y="3602873"/>
            <a:ext cx="1958395" cy="159232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D4BF311-E445-4BF9-9C32-E5F24F08924B}"/>
              </a:ext>
            </a:extLst>
          </p:cNvPr>
          <p:cNvSpPr txBox="1"/>
          <p:nvPr/>
        </p:nvSpPr>
        <p:spPr>
          <a:xfrm>
            <a:off x="3099816" y="5136172"/>
            <a:ext cx="2247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600   -400    -200        0       200    400    600</a:t>
            </a:r>
          </a:p>
        </p:txBody>
      </p:sp>
      <p:grpSp>
        <p:nvGrpSpPr>
          <p:cNvPr id="67" name="Group 66"/>
          <p:cNvGrpSpPr/>
          <p:nvPr/>
        </p:nvGrpSpPr>
        <p:grpSpPr>
          <a:xfrm>
            <a:off x="1746504" y="4426178"/>
            <a:ext cx="1207008" cy="604471"/>
            <a:chOff x="1197864" y="1787328"/>
            <a:chExt cx="1207008" cy="604471"/>
          </a:xfrm>
        </p:grpSpPr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CD5B19FE-9405-40C5-A499-BB9AD60F77B9}"/>
                </a:ext>
              </a:extLst>
            </p:cNvPr>
            <p:cNvCxnSpPr/>
            <p:nvPr/>
          </p:nvCxnSpPr>
          <p:spPr>
            <a:xfrm>
              <a:off x="2039112" y="2022432"/>
              <a:ext cx="36576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29FE39FE-A2D9-4814-BA24-D1511C2B9D8E}"/>
                </a:ext>
              </a:extLst>
            </p:cNvPr>
            <p:cNvCxnSpPr/>
            <p:nvPr/>
          </p:nvCxnSpPr>
          <p:spPr>
            <a:xfrm>
              <a:off x="2039112" y="1902188"/>
              <a:ext cx="3657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DCBF4E69-A4D2-4E5E-9464-0AA0A40DEA4F}"/>
                </a:ext>
              </a:extLst>
            </p:cNvPr>
            <p:cNvCxnSpPr/>
            <p:nvPr/>
          </p:nvCxnSpPr>
          <p:spPr>
            <a:xfrm>
              <a:off x="2039112" y="2146335"/>
              <a:ext cx="36576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ADA00F6C-930E-45F8-B0B9-2E2BA4F4515A}"/>
                </a:ext>
              </a:extLst>
            </p:cNvPr>
            <p:cNvCxnSpPr/>
            <p:nvPr/>
          </p:nvCxnSpPr>
          <p:spPr>
            <a:xfrm>
              <a:off x="2039112" y="2285660"/>
              <a:ext cx="365760" cy="0"/>
            </a:xfrm>
            <a:prstGeom prst="line">
              <a:avLst/>
            </a:prstGeom>
            <a:ln w="19050">
              <a:solidFill>
                <a:srgbClr val="EF19D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226330C-1257-47B8-80A9-92240657CC3F}"/>
                </a:ext>
              </a:extLst>
            </p:cNvPr>
            <p:cNvSpPr txBox="1"/>
            <p:nvPr/>
          </p:nvSpPr>
          <p:spPr>
            <a:xfrm>
              <a:off x="1703991" y="178732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ee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7515321-258B-450A-9E99-BDDE81610685}"/>
                </a:ext>
              </a:extLst>
            </p:cNvPr>
            <p:cNvSpPr txBox="1"/>
            <p:nvPr/>
          </p:nvSpPr>
          <p:spPr>
            <a:xfrm>
              <a:off x="1569271" y="1910655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aplan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AF05BAF-31DF-4BFA-BC75-C764A30E57CA}"/>
                </a:ext>
              </a:extLst>
            </p:cNvPr>
            <p:cNvSpPr txBox="1"/>
            <p:nvPr/>
          </p:nvSpPr>
          <p:spPr>
            <a:xfrm>
              <a:off x="1540304" y="2038968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vric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A8B8F27-05C8-4EB6-93D2-25F537387F3A}"/>
                </a:ext>
              </a:extLst>
            </p:cNvPr>
            <p:cNvSpPr txBox="1"/>
            <p:nvPr/>
          </p:nvSpPr>
          <p:spPr>
            <a:xfrm>
              <a:off x="1197864" y="2176355"/>
              <a:ext cx="8899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berbeckman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" name="Picture 5" descr="Chart, histogram&#10;&#10;Description automatically generated">
            <a:extLst>
              <a:ext uri="{FF2B5EF4-FFF2-40B4-BE49-F238E27FC236}">
                <a16:creationId xmlns:a16="http://schemas.microsoft.com/office/drawing/2014/main" id="{9EC8B647-8AEA-452A-B3E2-AE1914F64D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2" t="6341" r="8857" b="9281"/>
          <a:stretch/>
        </p:blipFill>
        <p:spPr>
          <a:xfrm>
            <a:off x="1093281" y="1448866"/>
            <a:ext cx="1944500" cy="1634785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43EA8871-0E36-4E6A-BC35-882837045DF3}"/>
              </a:ext>
            </a:extLst>
          </p:cNvPr>
          <p:cNvSpPr txBox="1"/>
          <p:nvPr/>
        </p:nvSpPr>
        <p:spPr>
          <a:xfrm>
            <a:off x="1028167" y="3046010"/>
            <a:ext cx="2117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         0.2        0.4        0.6        0.8          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DF6EBDD-8217-483C-853A-CF2B218881DB}"/>
              </a:ext>
            </a:extLst>
          </p:cNvPr>
          <p:cNvSpPr txBox="1"/>
          <p:nvPr/>
        </p:nvSpPr>
        <p:spPr>
          <a:xfrm rot="16200000">
            <a:off x="220933" y="2136445"/>
            <a:ext cx="12426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bability Density</a:t>
            </a: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242F13FF-7C75-4F22-A4D6-EBFBEC9EA5DC}"/>
              </a:ext>
            </a:extLst>
          </p:cNvPr>
          <p:cNvGrpSpPr/>
          <p:nvPr/>
        </p:nvGrpSpPr>
        <p:grpSpPr>
          <a:xfrm>
            <a:off x="1197864" y="1553114"/>
            <a:ext cx="1207008" cy="604471"/>
            <a:chOff x="1197864" y="1787328"/>
            <a:chExt cx="1207008" cy="604471"/>
          </a:xfrm>
        </p:grpSpPr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86D752CC-9928-4B42-9610-5DC35BFDB68E}"/>
                </a:ext>
              </a:extLst>
            </p:cNvPr>
            <p:cNvCxnSpPr/>
            <p:nvPr/>
          </p:nvCxnSpPr>
          <p:spPr>
            <a:xfrm>
              <a:off x="2039112" y="2022432"/>
              <a:ext cx="36576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26E0F5B5-4DE0-4CF6-B1E1-6559518FA89C}"/>
                </a:ext>
              </a:extLst>
            </p:cNvPr>
            <p:cNvCxnSpPr/>
            <p:nvPr/>
          </p:nvCxnSpPr>
          <p:spPr>
            <a:xfrm>
              <a:off x="2039112" y="1902188"/>
              <a:ext cx="3657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7C35CE6E-3F90-4526-8197-A10E87610795}"/>
                </a:ext>
              </a:extLst>
            </p:cNvPr>
            <p:cNvCxnSpPr/>
            <p:nvPr/>
          </p:nvCxnSpPr>
          <p:spPr>
            <a:xfrm>
              <a:off x="2039112" y="2146335"/>
              <a:ext cx="36576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3828EE7E-FB9A-41B3-B654-FD40F30C9386}"/>
                </a:ext>
              </a:extLst>
            </p:cNvPr>
            <p:cNvCxnSpPr/>
            <p:nvPr/>
          </p:nvCxnSpPr>
          <p:spPr>
            <a:xfrm>
              <a:off x="2039112" y="2285660"/>
              <a:ext cx="365760" cy="0"/>
            </a:xfrm>
            <a:prstGeom prst="line">
              <a:avLst/>
            </a:prstGeom>
            <a:ln w="19050">
              <a:solidFill>
                <a:srgbClr val="EF19D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C96175C-D580-461C-95F0-5FA8FC5FB53E}"/>
                </a:ext>
              </a:extLst>
            </p:cNvPr>
            <p:cNvSpPr txBox="1"/>
            <p:nvPr/>
          </p:nvSpPr>
          <p:spPr>
            <a:xfrm>
              <a:off x="1703991" y="178732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ee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54EC0323-B392-437E-B203-A7763D1EBF10}"/>
                </a:ext>
              </a:extLst>
            </p:cNvPr>
            <p:cNvSpPr txBox="1"/>
            <p:nvPr/>
          </p:nvSpPr>
          <p:spPr>
            <a:xfrm>
              <a:off x="1569271" y="1910655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aplan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4AF1DFFF-E5BD-4BE7-A29F-2D9CD803E23A}"/>
                </a:ext>
              </a:extLst>
            </p:cNvPr>
            <p:cNvSpPr txBox="1"/>
            <p:nvPr/>
          </p:nvSpPr>
          <p:spPr>
            <a:xfrm>
              <a:off x="1540304" y="2038968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vric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B95C183-249F-4D30-A728-1B0CDD55EF5E}"/>
                </a:ext>
              </a:extLst>
            </p:cNvPr>
            <p:cNvSpPr txBox="1"/>
            <p:nvPr/>
          </p:nvSpPr>
          <p:spPr>
            <a:xfrm>
              <a:off x="1197864" y="2176355"/>
              <a:ext cx="8899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berbeckman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6889D02C-B881-4733-A116-FD07A5530FD3}"/>
              </a:ext>
            </a:extLst>
          </p:cNvPr>
          <p:cNvSpPr txBox="1"/>
          <p:nvPr/>
        </p:nvSpPr>
        <p:spPr>
          <a:xfrm>
            <a:off x="901349" y="267768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1CA519F-923C-4E92-AB3E-ABCCC8DF3CA0}"/>
              </a:ext>
            </a:extLst>
          </p:cNvPr>
          <p:cNvSpPr txBox="1"/>
          <p:nvPr/>
        </p:nvSpPr>
        <p:spPr>
          <a:xfrm>
            <a:off x="869067" y="13823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8623562-DEEF-4957-896B-6ED7A37918EA}"/>
              </a:ext>
            </a:extLst>
          </p:cNvPr>
          <p:cNvSpPr txBox="1"/>
          <p:nvPr/>
        </p:nvSpPr>
        <p:spPr>
          <a:xfrm>
            <a:off x="869067" y="16122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71E1D65A-8025-4013-8F5F-1B99A2A7AF84}"/>
              </a:ext>
            </a:extLst>
          </p:cNvPr>
          <p:cNvSpPr txBox="1"/>
          <p:nvPr/>
        </p:nvSpPr>
        <p:spPr>
          <a:xfrm>
            <a:off x="908857" y="18857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6F65A15-0D05-4EA9-A5EE-8FD9E1797461}"/>
              </a:ext>
            </a:extLst>
          </p:cNvPr>
          <p:cNvSpPr txBox="1"/>
          <p:nvPr/>
        </p:nvSpPr>
        <p:spPr>
          <a:xfrm>
            <a:off x="905538" y="29323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61D408B-2FC7-4010-971B-C891A097FA51}"/>
              </a:ext>
            </a:extLst>
          </p:cNvPr>
          <p:cNvSpPr txBox="1"/>
          <p:nvPr/>
        </p:nvSpPr>
        <p:spPr>
          <a:xfrm>
            <a:off x="908857" y="24303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7844A21-2D82-49CF-9E03-14EC31333485}"/>
              </a:ext>
            </a:extLst>
          </p:cNvPr>
          <p:cNvSpPr txBox="1"/>
          <p:nvPr/>
        </p:nvSpPr>
        <p:spPr>
          <a:xfrm>
            <a:off x="905538" y="216347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F34C3AE-7316-4F5F-86ED-19F0F2E553BB}"/>
              </a:ext>
            </a:extLst>
          </p:cNvPr>
          <p:cNvSpPr txBox="1"/>
          <p:nvPr/>
        </p:nvSpPr>
        <p:spPr>
          <a:xfrm>
            <a:off x="683982" y="11490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Szövegdoboz 2">
            <a:extLst>
              <a:ext uri="{FF2B5EF4-FFF2-40B4-BE49-F238E27FC236}">
                <a16:creationId xmlns:a16="http://schemas.microsoft.com/office/drawing/2014/main" id="{677F5978-652A-43F8-855E-79CB088B5A8C}"/>
              </a:ext>
            </a:extLst>
          </p:cNvPr>
          <p:cNvSpPr txBox="1"/>
          <p:nvPr/>
        </p:nvSpPr>
        <p:spPr>
          <a:xfrm>
            <a:off x="417021" y="6891748"/>
            <a:ext cx="1421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zövegdoboz 4">
            <a:extLst>
              <a:ext uri="{FF2B5EF4-FFF2-40B4-BE49-F238E27FC236}">
                <a16:creationId xmlns:a16="http://schemas.microsoft.com/office/drawing/2014/main" id="{74B1418C-6272-4881-B17A-EFCAE5F258AB}"/>
              </a:ext>
            </a:extLst>
          </p:cNvPr>
          <p:cNvSpPr txBox="1"/>
          <p:nvPr/>
        </p:nvSpPr>
        <p:spPr>
          <a:xfrm>
            <a:off x="417021" y="7210065"/>
            <a:ext cx="6080094" cy="29546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. Lee, D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illo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N. Bray, R. H. Morse, R. W. Davis, T. R. Hughes and C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islow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"A high-resolution atlas of nucleosome occupancy in yeast,"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at. Genet.,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ol. 39, pp. 1235-1244, 2007.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. Kaplan, I. K. Moore, Y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ndufe-Mittendor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. J. Gossett, D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ill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Y. Field, E. M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eProu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. R. Hughes, J. D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ie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id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E. Segal, "The DNA-encoded nucleosome organization of a eukaryotic genome," Nature, pp. 362-366, 2009.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. 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vric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. P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oshikh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. J. Venters, C. Jiang, L. P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omsh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. Qi, S. C. Schuster, I. Albert and B. F. Pugh, "A barrier nucleosome model for statistical positioning of nucleosomes throughout the yeast genome," Genome Res., vol. 18, pp. 1073-1083, 2008.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. Wolff, 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ietenste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. Heron, J. L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li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. Schmid, S. Krebs, H. Blum, U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erlan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orb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Absolute nucleosome occupancy map for the Saccharomyces cerevisiae genome," Genome Res, vol. 29, pp. 1996-2009, 2019.</a:t>
            </a: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2250220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31</TotalTime>
  <Words>434</Words>
  <Application>Microsoft Office PowerPoint</Application>
  <PresentationFormat>A4 (210x297 mm)</PresentationFormat>
  <Paragraphs>47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82</cp:revision>
  <dcterms:created xsi:type="dcterms:W3CDTF">2018-02-11T19:58:29Z</dcterms:created>
  <dcterms:modified xsi:type="dcterms:W3CDTF">2020-12-31T07:14:36Z</dcterms:modified>
</cp:coreProperties>
</file>